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9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55" userDrawn="1">
          <p15:clr>
            <a:srgbClr val="A4A3A4"/>
          </p15:clr>
        </p15:guide>
        <p15:guide id="2" pos="25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00C800"/>
    <a:srgbClr val="FF0D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174" autoAdjust="0"/>
    <p:restoredTop sz="96242" autoAdjust="0"/>
  </p:normalViewPr>
  <p:slideViewPr>
    <p:cSldViewPr snapToGrid="0">
      <p:cViewPr varScale="1">
        <p:scale>
          <a:sx n="75" d="100"/>
          <a:sy n="75" d="100"/>
        </p:scale>
        <p:origin x="3750" y="54"/>
      </p:cViewPr>
      <p:guideLst>
        <p:guide orient="horz" pos="1555"/>
        <p:guide pos="250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ujii yuki" userId="d8ee8b45-4c62-4e1c-8e9e-8b27fac0861d" providerId="ADAL" clId="{CEEE1293-4798-42C3-9F53-D41EF1807E84}"/>
    <pc:docChg chg="delSld">
      <pc:chgData name="fujii yuki" userId="d8ee8b45-4c62-4e1c-8e9e-8b27fac0861d" providerId="ADAL" clId="{CEEE1293-4798-42C3-9F53-D41EF1807E84}" dt="2025-11-27T16:04:56.392" v="2" actId="47"/>
      <pc:docMkLst>
        <pc:docMk/>
      </pc:docMkLst>
      <pc:sldChg chg="del">
        <pc:chgData name="fujii yuki" userId="d8ee8b45-4c62-4e1c-8e9e-8b27fac0861d" providerId="ADAL" clId="{CEEE1293-4798-42C3-9F53-D41EF1807E84}" dt="2025-11-27T16:04:51.411" v="0" actId="47"/>
        <pc:sldMkLst>
          <pc:docMk/>
          <pc:sldMk cId="3729757294" sldId="402"/>
        </pc:sldMkLst>
      </pc:sldChg>
      <pc:sldChg chg="del">
        <pc:chgData name="fujii yuki" userId="d8ee8b45-4c62-4e1c-8e9e-8b27fac0861d" providerId="ADAL" clId="{CEEE1293-4798-42C3-9F53-D41EF1807E84}" dt="2025-11-27T16:04:55.372" v="1" actId="47"/>
        <pc:sldMkLst>
          <pc:docMk/>
          <pc:sldMk cId="1655998447" sldId="403"/>
        </pc:sldMkLst>
      </pc:sldChg>
      <pc:sldChg chg="del">
        <pc:chgData name="fujii yuki" userId="d8ee8b45-4c62-4e1c-8e9e-8b27fac0861d" providerId="ADAL" clId="{CEEE1293-4798-42C3-9F53-D41EF1807E84}" dt="2025-11-27T16:04:56.392" v="2" actId="47"/>
        <pc:sldMkLst>
          <pc:docMk/>
          <pc:sldMk cId="3988744911" sldId="40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58A73F-8879-4EFD-8A8F-3659792806E9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32B630-F6E4-44DA-A16B-4E43C3B0E0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093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895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33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629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85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902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042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355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173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342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097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4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17C350-7A19-46DE-B1B3-DCCD7993CD13}" type="datetimeFigureOut">
              <a:rPr kumimoji="1" lang="ja-JP" altLang="en-US" smtClean="0"/>
              <a:t>2025/11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20F80-7C95-4693-AA89-9AC90BF2CF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042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2BF3666-E28D-5D3A-A6CF-C0FE152530F2}"/>
              </a:ext>
            </a:extLst>
          </p:cNvPr>
          <p:cNvSpPr txBox="1"/>
          <p:nvPr/>
        </p:nvSpPr>
        <p:spPr>
          <a:xfrm>
            <a:off x="900925" y="944767"/>
            <a:ext cx="10324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3B</a:t>
            </a:r>
            <a:endParaRPr lang="en-US" altLang="ja-JP" sz="1400" b="1" kern="1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60C81423-3B28-21CD-6922-F1A5BBD9DDB2}"/>
              </a:ext>
            </a:extLst>
          </p:cNvPr>
          <p:cNvSpPr txBox="1"/>
          <p:nvPr/>
        </p:nvSpPr>
        <p:spPr>
          <a:xfrm rot="18699917">
            <a:off x="3594206" y="2998097"/>
            <a:ext cx="1010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77774C1-6CF1-D7B3-AB01-0E33C1D1BD5B}"/>
              </a:ext>
            </a:extLst>
          </p:cNvPr>
          <p:cNvSpPr txBox="1"/>
          <p:nvPr/>
        </p:nvSpPr>
        <p:spPr>
          <a:xfrm rot="18699917">
            <a:off x="3877326" y="2979397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WT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515BC810-7F4D-C1DB-C88C-A4B7215E49E2}"/>
              </a:ext>
            </a:extLst>
          </p:cNvPr>
          <p:cNvSpPr txBox="1"/>
          <p:nvPr/>
        </p:nvSpPr>
        <p:spPr>
          <a:xfrm rot="18699917">
            <a:off x="4135806" y="2984748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287A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57CB17F-520D-5BFF-F37E-5DA5A6609E71}"/>
              </a:ext>
            </a:extLst>
          </p:cNvPr>
          <p:cNvSpPr txBox="1"/>
          <p:nvPr/>
        </p:nvSpPr>
        <p:spPr>
          <a:xfrm rot="18699917">
            <a:off x="4410337" y="3011445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287A/K43M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6F4977-91FF-37CB-5FDA-3D30CEFF8279}"/>
              </a:ext>
            </a:extLst>
          </p:cNvPr>
          <p:cNvSpPr txBox="1"/>
          <p:nvPr/>
        </p:nvSpPr>
        <p:spPr>
          <a:xfrm>
            <a:off x="4853915" y="3717348"/>
            <a:ext cx="444788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5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146E830-887F-AAD2-72ED-32C1DCB100AC}"/>
              </a:ext>
            </a:extLst>
          </p:cNvPr>
          <p:cNvSpPr txBox="1"/>
          <p:nvPr/>
        </p:nvSpPr>
        <p:spPr>
          <a:xfrm>
            <a:off x="4851534" y="3513513"/>
            <a:ext cx="444788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6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9A4B9FB0-FEE0-3A77-2EE3-E4238785460A}"/>
              </a:ext>
            </a:extLst>
          </p:cNvPr>
          <p:cNvGrpSpPr/>
          <p:nvPr/>
        </p:nvGrpSpPr>
        <p:grpSpPr>
          <a:xfrm>
            <a:off x="3595376" y="3499288"/>
            <a:ext cx="1430784" cy="712816"/>
            <a:chOff x="3411634" y="5370286"/>
            <a:chExt cx="1430784" cy="712816"/>
          </a:xfrm>
        </p:grpSpPr>
        <p:pic>
          <p:nvPicPr>
            <p:cNvPr id="38" name="図 37" descr="暗い部屋の中に入っている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152F8D88-2546-507A-BA16-FD8634A94DE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9857" t="37833" r="44205" b="35311"/>
            <a:stretch>
              <a:fillRect/>
            </a:stretch>
          </p:blipFill>
          <p:spPr>
            <a:xfrm>
              <a:off x="3411634" y="5370286"/>
              <a:ext cx="1430784" cy="712816"/>
            </a:xfrm>
            <a:prstGeom prst="rect">
              <a:avLst/>
            </a:prstGeom>
          </p:spPr>
        </p:pic>
        <p:pic>
          <p:nvPicPr>
            <p:cNvPr id="40" name="図 39" descr="白い背景に黒い文字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D1D16CB4-1646-1007-F54C-08BEE984C16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4075" t="42335" r="46364" b="37263"/>
            <a:stretch>
              <a:fillRect/>
            </a:stretch>
          </p:blipFill>
          <p:spPr>
            <a:xfrm>
              <a:off x="3579562" y="5489791"/>
              <a:ext cx="1176930" cy="541492"/>
            </a:xfrm>
            <a:prstGeom prst="rect">
              <a:avLst/>
            </a:prstGeom>
          </p:spPr>
        </p:pic>
      </p:grp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D29B64F-80DF-E3F4-3DB3-E281BA002EFA}"/>
              </a:ext>
            </a:extLst>
          </p:cNvPr>
          <p:cNvSpPr txBox="1"/>
          <p:nvPr/>
        </p:nvSpPr>
        <p:spPr>
          <a:xfrm>
            <a:off x="3737041" y="4279790"/>
            <a:ext cx="11474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B : α-tubulin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20F8213-A3D6-1AF8-7E6A-9CFB8EE395FE}"/>
              </a:ext>
            </a:extLst>
          </p:cNvPr>
          <p:cNvSpPr txBox="1"/>
          <p:nvPr/>
        </p:nvSpPr>
        <p:spPr>
          <a:xfrm>
            <a:off x="2418985" y="3150343"/>
            <a:ext cx="478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75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D254336-DF93-A22A-B2FD-DB44B4CE7A36}"/>
              </a:ext>
            </a:extLst>
          </p:cNvPr>
          <p:cNvSpPr txBox="1"/>
          <p:nvPr/>
        </p:nvSpPr>
        <p:spPr>
          <a:xfrm>
            <a:off x="2411795" y="3278649"/>
            <a:ext cx="478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6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C35A6EF-C870-C370-D2B2-EE9E069C5B96}"/>
              </a:ext>
            </a:extLst>
          </p:cNvPr>
          <p:cNvSpPr txBox="1"/>
          <p:nvPr/>
        </p:nvSpPr>
        <p:spPr>
          <a:xfrm>
            <a:off x="1431336" y="5330395"/>
            <a:ext cx="11083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B : GFP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DB3D9B7-B95E-07D7-9EB3-07FCC73BBAA7}"/>
              </a:ext>
            </a:extLst>
          </p:cNvPr>
          <p:cNvSpPr txBox="1"/>
          <p:nvPr/>
        </p:nvSpPr>
        <p:spPr>
          <a:xfrm>
            <a:off x="2399095" y="4064833"/>
            <a:ext cx="478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2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6044021-120B-E0EB-5D1E-CC5AB9CF846F}"/>
              </a:ext>
            </a:extLst>
          </p:cNvPr>
          <p:cNvSpPr txBox="1"/>
          <p:nvPr/>
        </p:nvSpPr>
        <p:spPr>
          <a:xfrm>
            <a:off x="2408469" y="3519252"/>
            <a:ext cx="478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4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293614F5-EA34-AAC8-600F-479D6F7DFD51}"/>
              </a:ext>
            </a:extLst>
          </p:cNvPr>
          <p:cNvGrpSpPr/>
          <p:nvPr/>
        </p:nvGrpSpPr>
        <p:grpSpPr>
          <a:xfrm>
            <a:off x="1136178" y="2833913"/>
            <a:ext cx="1488056" cy="2482421"/>
            <a:chOff x="1144021" y="4458965"/>
            <a:chExt cx="1488056" cy="2654208"/>
          </a:xfrm>
        </p:grpSpPr>
        <p:pic>
          <p:nvPicPr>
            <p:cNvPr id="32" name="図 31" descr="モニター, 写真, 座る, テレビ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12888317-81C4-8612-3783-2C6A1F59EB4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13000" contrast="-30000"/>
                      </a14:imgEffect>
                    </a14:imgLayer>
                  </a14:imgProps>
                </a:ext>
              </a:extLst>
            </a:blip>
            <a:srcRect r="62624"/>
            <a:stretch>
              <a:fillRect/>
            </a:stretch>
          </p:blipFill>
          <p:spPr>
            <a:xfrm>
              <a:off x="1144021" y="4458965"/>
              <a:ext cx="1488056" cy="2654208"/>
            </a:xfrm>
            <a:prstGeom prst="rect">
              <a:avLst/>
            </a:prstGeom>
          </p:spPr>
        </p:pic>
        <p:pic>
          <p:nvPicPr>
            <p:cNvPr id="35" name="図 34" descr="飛ぶ, 鳥, スキー, 飛行機 が含まれている画像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3B09E87D-5069-9BE3-9C9C-A64A538C9C1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5560" r="63471"/>
            <a:stretch>
              <a:fillRect/>
            </a:stretch>
          </p:blipFill>
          <p:spPr>
            <a:xfrm>
              <a:off x="1365363" y="4458965"/>
              <a:ext cx="1232952" cy="2654208"/>
            </a:xfrm>
            <a:prstGeom prst="rect">
              <a:avLst/>
            </a:prstGeom>
          </p:spPr>
        </p:pic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4ADB2B9-423B-EB46-6633-96DEEB8EC851}"/>
              </a:ext>
            </a:extLst>
          </p:cNvPr>
          <p:cNvSpPr txBox="1"/>
          <p:nvPr/>
        </p:nvSpPr>
        <p:spPr>
          <a:xfrm rot="18699917">
            <a:off x="1294196" y="2315893"/>
            <a:ext cx="1010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GFP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66101F5-BBC4-FC9F-91C7-C6A56194C085}"/>
              </a:ext>
            </a:extLst>
          </p:cNvPr>
          <p:cNvSpPr txBox="1"/>
          <p:nvPr/>
        </p:nvSpPr>
        <p:spPr>
          <a:xfrm rot="18699917">
            <a:off x="1545171" y="2279398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WT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4D92F42-2F73-E92A-9ED2-B937FD2FE626}"/>
              </a:ext>
            </a:extLst>
          </p:cNvPr>
          <p:cNvSpPr txBox="1"/>
          <p:nvPr/>
        </p:nvSpPr>
        <p:spPr>
          <a:xfrm rot="18699917">
            <a:off x="1805547" y="2316897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287A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5D79F26-B31B-6553-D031-42F71D10595C}"/>
              </a:ext>
            </a:extLst>
          </p:cNvPr>
          <p:cNvSpPr txBox="1"/>
          <p:nvPr/>
        </p:nvSpPr>
        <p:spPr>
          <a:xfrm rot="18699917">
            <a:off x="2090365" y="2328650"/>
            <a:ext cx="10100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T287A/K43M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1F9D874-12F6-D7D2-DB56-834F80E77E8A}"/>
              </a:ext>
            </a:extLst>
          </p:cNvPr>
          <p:cNvSpPr txBox="1"/>
          <p:nvPr/>
        </p:nvSpPr>
        <p:spPr>
          <a:xfrm>
            <a:off x="2414669" y="3732439"/>
            <a:ext cx="478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900" kern="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3</a:t>
            </a:r>
            <a:r>
              <a:rPr kumimoji="0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0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96B46E8-72C2-D3ED-F781-5A918E593D38}"/>
              </a:ext>
            </a:extLst>
          </p:cNvPr>
          <p:cNvSpPr txBox="1"/>
          <p:nvPr/>
        </p:nvSpPr>
        <p:spPr>
          <a:xfrm>
            <a:off x="918740" y="6192653"/>
            <a:ext cx="4847433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>
                <a:latin typeface="Helvetica" panose="020B0604020202020204" pitchFamily="34" charset="0"/>
                <a:cs typeface="Helvetica" panose="020B0604020202020204" pitchFamily="34" charset="0"/>
              </a:rPr>
              <a:t>The area enclosed by the red box was cropped and used in the Figure.</a:t>
            </a:r>
            <a:endParaRPr lang="ja-JP" altLang="en-US" sz="105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1993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536</TotalTime>
  <Words>48</Words>
  <Application>Microsoft Office PowerPoint</Application>
  <PresentationFormat>A4 210 x 297 mm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MK2論文Fig案-1</dc:title>
  <dc:creator>fujii yuki</dc:creator>
  <cp:lastModifiedBy>fujii yuki</cp:lastModifiedBy>
  <cp:revision>87</cp:revision>
  <dcterms:created xsi:type="dcterms:W3CDTF">2022-12-21T09:45:59Z</dcterms:created>
  <dcterms:modified xsi:type="dcterms:W3CDTF">2025-11-27T16:04:58Z</dcterms:modified>
</cp:coreProperties>
</file>